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702314-D00D-4343-B00D-988ADA71DE21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6564A-84AA-4084-9291-1E3AFE6BF1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455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49500" y="1163638"/>
            <a:ext cx="2354263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CA37C-5DFD-4879-8318-0724237D61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094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656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96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404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588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23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02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27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192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437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43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626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EBE8A-DDF6-452E-908F-03A694F8C2DE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FE57E-93B2-4278-9DF8-2D9915DBB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984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50A2063-2978-4202-BFFA-53F97C50430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72" r="50715" b="2879"/>
          <a:stretch/>
        </p:blipFill>
        <p:spPr>
          <a:xfrm>
            <a:off x="653555" y="1324510"/>
            <a:ext cx="1288897" cy="274748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34951DF-1974-47B0-9148-15B34589B40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63" r="54994" b="2879"/>
          <a:stretch/>
        </p:blipFill>
        <p:spPr>
          <a:xfrm>
            <a:off x="2297356" y="1324510"/>
            <a:ext cx="1314932" cy="274748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DAAD321-D51A-4581-A71C-57D363BF858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470" r="54486" b="2879"/>
          <a:stretch/>
        </p:blipFill>
        <p:spPr>
          <a:xfrm>
            <a:off x="730257" y="5319279"/>
            <a:ext cx="1158396" cy="274748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660BE60-8662-4FD5-8577-E4A0F35E2DF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57" r="56200" b="3080"/>
          <a:stretch/>
        </p:blipFill>
        <p:spPr>
          <a:xfrm>
            <a:off x="2302746" y="5316022"/>
            <a:ext cx="1215109" cy="274177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46E66A9-4198-4F6A-B30D-2C80EBEC862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737" t="1866" r="24610" b="95865"/>
          <a:stretch/>
        </p:blipFill>
        <p:spPr>
          <a:xfrm>
            <a:off x="534941" y="539923"/>
            <a:ext cx="5913982" cy="214395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5BE2995E-6EE2-4317-B99E-D2895B35ACDD}"/>
              </a:ext>
            </a:extLst>
          </p:cNvPr>
          <p:cNvSpPr/>
          <p:nvPr/>
        </p:nvSpPr>
        <p:spPr>
          <a:xfrm>
            <a:off x="1762728" y="103194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YQWDDPDP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3E24EF5-83EE-4B15-BD84-C4CFC32C2D47}"/>
              </a:ext>
            </a:extLst>
          </p:cNvPr>
          <p:cNvSpPr txBox="1"/>
          <p:nvPr/>
        </p:nvSpPr>
        <p:spPr>
          <a:xfrm>
            <a:off x="2170400" y="4821570"/>
            <a:ext cx="15553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ermentino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63ED7C6-C570-45FC-BC24-1709F5E8D503}"/>
              </a:ext>
            </a:extLst>
          </p:cNvPr>
          <p:cNvSpPr txBox="1"/>
          <p:nvPr/>
        </p:nvSpPr>
        <p:spPr>
          <a:xfrm>
            <a:off x="609508" y="4913904"/>
            <a:ext cx="1555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0349A91-7086-4AA5-9994-E249D08E11B6}"/>
              </a:ext>
            </a:extLst>
          </p:cNvPr>
          <p:cNvSpPr txBox="1"/>
          <p:nvPr/>
        </p:nvSpPr>
        <p:spPr>
          <a:xfrm>
            <a:off x="814502" y="4007252"/>
            <a:ext cx="1074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CD531E-0550-47DE-B22C-CFF4F11F7499}"/>
              </a:ext>
            </a:extLst>
          </p:cNvPr>
          <p:cNvSpPr txBox="1"/>
          <p:nvPr/>
        </p:nvSpPr>
        <p:spPr>
          <a:xfrm>
            <a:off x="252610" y="2017676"/>
            <a:ext cx="369332" cy="129843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2A3357A-18EB-422D-A6B9-71BB375508EE}"/>
              </a:ext>
            </a:extLst>
          </p:cNvPr>
          <p:cNvSpPr txBox="1"/>
          <p:nvPr/>
        </p:nvSpPr>
        <p:spPr>
          <a:xfrm>
            <a:off x="2470785" y="4007252"/>
            <a:ext cx="10740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7B8BEE5-518D-413B-BFD1-AD2DE5E13252}"/>
              </a:ext>
            </a:extLst>
          </p:cNvPr>
          <p:cNvSpPr txBox="1"/>
          <p:nvPr/>
        </p:nvSpPr>
        <p:spPr>
          <a:xfrm>
            <a:off x="1953308" y="2017676"/>
            <a:ext cx="369332" cy="129843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DBB91DF-14BA-4F81-81C1-83926E19E0C0}"/>
              </a:ext>
            </a:extLst>
          </p:cNvPr>
          <p:cNvSpPr txBox="1"/>
          <p:nvPr/>
        </p:nvSpPr>
        <p:spPr>
          <a:xfrm>
            <a:off x="889176" y="8000394"/>
            <a:ext cx="9105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DF58C1-89EB-4140-A753-D655818FE15C}"/>
              </a:ext>
            </a:extLst>
          </p:cNvPr>
          <p:cNvSpPr txBox="1"/>
          <p:nvPr/>
        </p:nvSpPr>
        <p:spPr>
          <a:xfrm>
            <a:off x="252610" y="6012444"/>
            <a:ext cx="369332" cy="129843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28548E4-7A38-437A-B8D6-1A41092FC4D7}"/>
              </a:ext>
            </a:extLst>
          </p:cNvPr>
          <p:cNvSpPr txBox="1"/>
          <p:nvPr/>
        </p:nvSpPr>
        <p:spPr>
          <a:xfrm>
            <a:off x="2517522" y="8000394"/>
            <a:ext cx="9105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tention Tim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16A001E-3DE4-4BF2-9F54-73C1E6E41A9E}"/>
              </a:ext>
            </a:extLst>
          </p:cNvPr>
          <p:cNvSpPr txBox="1"/>
          <p:nvPr/>
        </p:nvSpPr>
        <p:spPr>
          <a:xfrm>
            <a:off x="1953308" y="6009190"/>
            <a:ext cx="369332" cy="1298432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E1CA2226-3631-4724-A3F7-BD0743BA24B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147" t="3888" b="2823"/>
          <a:stretch/>
        </p:blipFill>
        <p:spPr>
          <a:xfrm>
            <a:off x="4784567" y="3193663"/>
            <a:ext cx="1610139" cy="3350263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98E21BC5-A22A-40CF-A77A-AE467534FF55}"/>
              </a:ext>
            </a:extLst>
          </p:cNvPr>
          <p:cNvSpPr/>
          <p:nvPr/>
        </p:nvSpPr>
        <p:spPr>
          <a:xfrm>
            <a:off x="4526264" y="2509705"/>
            <a:ext cx="19607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Spectra for FASN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YQWDDPDPR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F5996E5-9BC8-4F18-99FE-B903387A1414}"/>
              </a:ext>
            </a:extLst>
          </p:cNvPr>
          <p:cNvSpPr txBox="1"/>
          <p:nvPr/>
        </p:nvSpPr>
        <p:spPr>
          <a:xfrm>
            <a:off x="4997451" y="6543927"/>
            <a:ext cx="1304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7321556-EDCA-4D15-8049-3AA84EC31A70}"/>
              </a:ext>
            </a:extLst>
          </p:cNvPr>
          <p:cNvSpPr txBox="1"/>
          <p:nvPr/>
        </p:nvSpPr>
        <p:spPr>
          <a:xfrm rot="16200000">
            <a:off x="3992292" y="4725318"/>
            <a:ext cx="13049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ensity (10^6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BEE6A81-941F-4A30-A846-0B6FB78D50BE}"/>
              </a:ext>
            </a:extLst>
          </p:cNvPr>
          <p:cNvSpPr txBox="1"/>
          <p:nvPr/>
        </p:nvSpPr>
        <p:spPr>
          <a:xfrm>
            <a:off x="3787103" y="8737369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16409F2-3AA3-4DD1-9D86-94975F70269A}"/>
              </a:ext>
            </a:extLst>
          </p:cNvPr>
          <p:cNvSpPr txBox="1"/>
          <p:nvPr/>
        </p:nvSpPr>
        <p:spPr>
          <a:xfrm>
            <a:off x="2170400" y="931132"/>
            <a:ext cx="15553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ermentino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89B824A-6111-4CCB-AE0D-6068D8F3017A}"/>
              </a:ext>
            </a:extLst>
          </p:cNvPr>
          <p:cNvSpPr txBox="1"/>
          <p:nvPr/>
        </p:nvSpPr>
        <p:spPr>
          <a:xfrm>
            <a:off x="609508" y="1023465"/>
            <a:ext cx="1555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2" name="Left Bracket 41">
            <a:extLst>
              <a:ext uri="{FF2B5EF4-FFF2-40B4-BE49-F238E27FC236}">
                <a16:creationId xmlns:a16="http://schemas.microsoft.com/office/drawing/2014/main" id="{3F5520DE-CBD5-40D8-98FE-DD9B49DFDAA4}"/>
              </a:ext>
            </a:extLst>
          </p:cNvPr>
          <p:cNvSpPr/>
          <p:nvPr/>
        </p:nvSpPr>
        <p:spPr>
          <a:xfrm>
            <a:off x="265047" y="878106"/>
            <a:ext cx="105547" cy="357136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Left Bracket 42">
            <a:extLst>
              <a:ext uri="{FF2B5EF4-FFF2-40B4-BE49-F238E27FC236}">
                <a16:creationId xmlns:a16="http://schemas.microsoft.com/office/drawing/2014/main" id="{A38991E4-CCE5-4174-B495-C3AA616DED79}"/>
              </a:ext>
            </a:extLst>
          </p:cNvPr>
          <p:cNvSpPr/>
          <p:nvPr/>
        </p:nvSpPr>
        <p:spPr>
          <a:xfrm>
            <a:off x="270931" y="4799880"/>
            <a:ext cx="105547" cy="357136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BAD65B0-6F5A-439D-9D43-ABD0B1B1EE7E}"/>
              </a:ext>
            </a:extLst>
          </p:cNvPr>
          <p:cNvSpPr txBox="1"/>
          <p:nvPr/>
        </p:nvSpPr>
        <p:spPr>
          <a:xfrm rot="16200000">
            <a:off x="-725418" y="2317083"/>
            <a:ext cx="1777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E48F88A-12C2-43AF-9E1D-B69CD86261B3}"/>
              </a:ext>
            </a:extLst>
          </p:cNvPr>
          <p:cNvSpPr txBox="1"/>
          <p:nvPr/>
        </p:nvSpPr>
        <p:spPr>
          <a:xfrm rot="16200000">
            <a:off x="-725418" y="6290764"/>
            <a:ext cx="1777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KBR-3</a:t>
            </a:r>
          </a:p>
        </p:txBody>
      </p:sp>
    </p:spTree>
    <p:extLst>
      <p:ext uri="{BB962C8B-B14F-4D97-AF65-F5344CB8AC3E}">
        <p14:creationId xmlns:p14="http://schemas.microsoft.com/office/powerpoint/2010/main" val="842788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8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1</cp:revision>
  <dcterms:created xsi:type="dcterms:W3CDTF">2020-02-18T22:38:03Z</dcterms:created>
  <dcterms:modified xsi:type="dcterms:W3CDTF">2020-02-18T22:38:33Z</dcterms:modified>
</cp:coreProperties>
</file>